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1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948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18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502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9938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3291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2667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544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697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8797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935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506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DE6FA-419F-4F33-9364-8E203B5F536B}" type="datetimeFigureOut">
              <a:rPr kumimoji="1" lang="ja-JP" altLang="en-US" smtClean="0"/>
              <a:t>2020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000455-E3C0-481D-8964-22A76669AF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398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5F897A3-3FEB-4F9D-9EA3-D60203823815}"/>
              </a:ext>
            </a:extLst>
          </p:cNvPr>
          <p:cNvSpPr txBox="1"/>
          <p:nvPr/>
        </p:nvSpPr>
        <p:spPr>
          <a:xfrm>
            <a:off x="809575" y="-2264"/>
            <a:ext cx="4138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 dirty="0"/>
              <a:t>Supplemental Table S2. PCR primers used in the present study</a:t>
            </a:r>
            <a:endParaRPr kumimoji="1" lang="ja-JP" altLang="en-US" sz="1200" b="1" dirty="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1EB2BE60-8077-48F0-A12F-C51FDFE457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2871178"/>
              </p:ext>
            </p:extLst>
          </p:nvPr>
        </p:nvGraphicFramePr>
        <p:xfrm>
          <a:off x="55097" y="333458"/>
          <a:ext cx="9046958" cy="6424331"/>
        </p:xfrm>
        <a:graphic>
          <a:graphicData uri="http://schemas.openxmlformats.org/drawingml/2006/table">
            <a:tbl>
              <a:tblPr/>
              <a:tblGrid>
                <a:gridCol w="1312309">
                  <a:extLst>
                    <a:ext uri="{9D8B030D-6E8A-4147-A177-3AD203B41FA5}">
                      <a16:colId xmlns:a16="http://schemas.microsoft.com/office/drawing/2014/main" val="4256589174"/>
                    </a:ext>
                  </a:extLst>
                </a:gridCol>
                <a:gridCol w="3045203">
                  <a:extLst>
                    <a:ext uri="{9D8B030D-6E8A-4147-A177-3AD203B41FA5}">
                      <a16:colId xmlns:a16="http://schemas.microsoft.com/office/drawing/2014/main" val="2696821799"/>
                    </a:ext>
                  </a:extLst>
                </a:gridCol>
                <a:gridCol w="4689446">
                  <a:extLst>
                    <a:ext uri="{9D8B030D-6E8A-4147-A177-3AD203B41FA5}">
                      <a16:colId xmlns:a16="http://schemas.microsoft.com/office/drawing/2014/main" val="2044955527"/>
                    </a:ext>
                  </a:extLst>
                </a:gridCol>
              </a:tblGrid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rimers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equences (5’ to 3’)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urpose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565873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INTE_FFA 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GAAAAGGAAATATAC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intestin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3800118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INTE_FFA 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AGGTTGCCATACTTCCT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intestin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1979469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INU_FFA 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AGCAATATGTTAGAAAAA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inulinivoran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067721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INU_FFA 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CTCAATAATTTCGTCGTT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inulinivoran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3472722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_S6PH1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TTTGAGAAATATAAAAAAGT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8382627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_S6PH1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TCTTCATTGCATCCTCCTTCG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6565482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_S6PH2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GAATGGCCAAGAT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8380683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_S6PH2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CAGTTTCAGATCCCAGATGGA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5253072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_LamG_F4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aatctaaaagatccATGAAAAAAGTTTTGACCAGGAT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whole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 (</a:t>
                      </a:r>
                      <a:r>
                        <a:rPr lang="en-US" altLang="ja-JP" sz="1000" b="0" dirty="0"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NBU17_10420-1043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887483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_LamG_R4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tttaccagactcgagTTATTTTACTCTAATTGTTACT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whole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 (</a:t>
                      </a:r>
                      <a:r>
                        <a:rPr lang="en-US" altLang="ja-JP" sz="1000" b="0" dirty="0"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NBU17_10420-1043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5229456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kumimoji="1" lang="en-US" altLang="ja-JP" sz="1000" b="0" i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_LamG_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kumimoji="1" lang="en-US" altLang="ja-JP" sz="1000" b="0" i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aaggagatataccATGACAGAAGGACAATTT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partial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 (</a:t>
                      </a:r>
                      <a:r>
                        <a:rPr lang="en-US" altLang="ja-JP" sz="1000" b="0" dirty="0"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NBU17_1042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246054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kumimoji="1" lang="en-US" altLang="ja-JP" sz="1000" b="0" i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_LamG_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kumimoji="1" lang="en-US" altLang="ja-JP" sz="1000" b="0" i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ggtggtgctcgagTTATTTTACTCTAATTGTT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partial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butyratic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 (</a:t>
                      </a:r>
                      <a:r>
                        <a:rPr lang="en-US" altLang="ja-JP" sz="1000" b="0" dirty="0"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NBU17_1042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2661157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S6PH1_F1.5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TTTGAAAAATACAAGAAAGT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3444896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S6PH1_R1.5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TCTTCATGTCTTCCTCCTTCAATTTC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1921408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S6PH2_F1.4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AAATTTTTAGATGTAG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785062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S6PH2_R1.4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AATTAAATTAATTTCCACATTTTCT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3750676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GH32_F1.39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TATCAGTTATATTATC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5985442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GH32_R1.39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TTGTTTATTTTTGTTGCT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62926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LamG_F4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aatctaaaagatccCCAGTAACAGCATACAATCATGTAA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4 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51453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H_LamG_R4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tttaccagactcgagTTAATTTGCTTTCACTGACTTCGCATTA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hadr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4 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7934802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His_Inf_FaeA2-165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AACGATTTGACTTTAC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F.prausnitzii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83587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His_Inf_FaeA2-165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CAGATTCAGTTCAAACTGTTCCG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F.prausnitzii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310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R_S6PH_F1.46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AGCGAATTATTGGAAAAA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rect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8382374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R_S6PH_R1.46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ATTATATCATATTTTTCAATAT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rect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66522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R_RS01270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GGGCGATTATTTTATAAA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rect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26870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R_RS01270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CTCGCTCCTTTTTTCTTTATATT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.rectal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317671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1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GATATAAATGGGAAG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194669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1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AATTATATCATACTTCTCCAC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1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2669357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2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TATACATGCCAGAAGGCAG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482599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2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ATGTTCAGATCGTATTTCTCCACCT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2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839258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3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GAGATTTTTAGAAAGATGT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9014606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E3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CTTTCCTGTGATCTCTATGTC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.eutactu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32-3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2771385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FAE_FFA_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gaaggagatataccATGAGTGAGATGTTAAAA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faec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0273368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FAE_FFA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tggtggtgctcgagTAATATAATATCATACTTTT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of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.faeci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GH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983023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ET28a_5300F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TCGAGCACCACCACCACCACCACTGAGATCC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and linearization of pET28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4823190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ET28a_5300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GTATATCTCCTTCTTAAAGTTAAACAAA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and linearization of pET28a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2085536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CDF_PgsA_F_5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TCGAGTCTGGTAAAGAAACCGCTGCTGC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and linearization of </a:t>
                      </a:r>
                      <a:r>
                        <a:rPr kumimoji="1" lang="en-US" altLang="ja-JP" sz="10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CDF-Pgs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3317603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CDF_PgsA_R_5K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GATCTTTTAGATTTTAGTTTGTCACTAT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mplification and linearization of </a:t>
                      </a:r>
                      <a:r>
                        <a:rPr kumimoji="1" lang="en-US" altLang="ja-JP" sz="10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CDF-Pgs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7661034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B_LamG_fusio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Q)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AGGATGATGCCTTGACAGAAGGACAATTTG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eplacement of </a:t>
                      </a:r>
                      <a:r>
                        <a:rPr kumimoji="1" lang="en-US" altLang="ja-JP" sz="10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(TAG) to glutamine codon (CAG)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in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CDF_PgsA_AB_LamG_P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8399559"/>
                  </a:ext>
                </a:extLst>
              </a:tr>
              <a:tr h="1115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AB_LamG_fusio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Q)_R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GCCGCCAAGTACTGCAGCGGCATTATTCGATG</a:t>
                      </a: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Replacement of </a:t>
                      </a:r>
                      <a:r>
                        <a:rPr kumimoji="1" lang="en-US" altLang="ja-JP" sz="10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(TAG) to glutamine codon (CAG) 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in </a:t>
                      </a:r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pCDF_PgsA_AB_LamG_Pre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</a:endParaRPr>
                    </a:p>
                  </a:txBody>
                  <a:tcPr marL="36000" marR="4291" marT="429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4117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21734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23</Words>
  <Application>Microsoft Office PowerPoint</Application>
  <PresentationFormat>画面に合わせる (4:3)</PresentationFormat>
  <Paragraphs>1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hito Endo</dc:creator>
  <cp:lastModifiedBy>Akihito Endo</cp:lastModifiedBy>
  <cp:revision>2</cp:revision>
  <dcterms:created xsi:type="dcterms:W3CDTF">2020-08-05T06:33:49Z</dcterms:created>
  <dcterms:modified xsi:type="dcterms:W3CDTF">2020-10-13T04:51:04Z</dcterms:modified>
</cp:coreProperties>
</file>